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>
        <p:scale>
          <a:sx n="87" d="100"/>
          <a:sy n="87" d="100"/>
        </p:scale>
        <p:origin x="451" y="-4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B987356-BADD-44D9-B9A9-57648DCA2106}" type="datetimeFigureOut">
              <a:rPr lang="en-US" smtClean="0"/>
              <a:t>2/17/20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7359896-B209-4A33-8AF5-5E01328078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891137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7359896-B209-4A33-8AF5-5E01328078F6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225585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D405618-079B-E059-4A02-69C14976BAA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30BE1C0-FCE4-2042-7984-53641994329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FEFCE2B-6407-F31A-D4F4-EDA032BBEE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144BAA-6DA9-41D4-8889-B358DD12E476}" type="datetimeFigureOut">
              <a:rPr lang="en-US" smtClean="0"/>
              <a:t>2/17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6773821-1A03-9D7D-1E72-050C89DD72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674025F-C2F6-ED73-6037-6E1BA2E5EA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6926A0-4598-48F0-AF2B-5C818EA327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09270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02B19A-C125-6AA1-D62B-18C692439BC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6588D1A-47C4-9620-F0B0-7CE8BB378FE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55DF102-E7E8-D0FA-CF8F-1837F29CBA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144BAA-6DA9-41D4-8889-B358DD12E476}" type="datetimeFigureOut">
              <a:rPr lang="en-US" smtClean="0"/>
              <a:t>2/17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22C401B-264F-5262-3E53-2D939F640E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39F385D-ECD9-19FD-B378-5203B6FCD3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6926A0-4598-48F0-AF2B-5C818EA327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05592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45AD02C-71DD-D57B-4846-D2769C76430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4F7B466-DDE5-2C34-CCB7-0C37335F653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EA43870-5934-34E8-0C23-B148B3D5F8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144BAA-6DA9-41D4-8889-B358DD12E476}" type="datetimeFigureOut">
              <a:rPr lang="en-US" smtClean="0"/>
              <a:t>2/17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38E2E1C-A649-8281-B054-5B1DEAF931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5EC070F-5B5E-26AD-886C-B34BF4E3FA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6926A0-4598-48F0-AF2B-5C818EA327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45722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AE49796-4333-6E90-D441-37DEEBFC44D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91D722F-7813-CDCE-DCA5-99BFD85BDC1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FE7598B-7071-AFDE-FD37-681E9E5B3A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144BAA-6DA9-41D4-8889-B358DD12E476}" type="datetimeFigureOut">
              <a:rPr lang="en-US" smtClean="0"/>
              <a:t>2/17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E275762-8B94-BCE7-D5C8-2051892766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5FECDD4-8E55-0F5E-09B5-5D5BFEB5A1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6926A0-4598-48F0-AF2B-5C818EA327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13377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4A946F4-2A16-CE29-5C96-8697008077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7496091-B6C8-21B2-141B-154142999FA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2C9340C-03DD-AB22-B255-15EAF5703F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144BAA-6DA9-41D4-8889-B358DD12E476}" type="datetimeFigureOut">
              <a:rPr lang="en-US" smtClean="0"/>
              <a:t>2/17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949452B-DBE3-E5D1-8674-442988DEAB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4CF6CDB-A79D-0356-F673-05776E4F89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6926A0-4598-48F0-AF2B-5C818EA327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32077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D0EC9B5-8B2C-CE13-ADAF-AC2B6F04387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03281DD-E1B6-C48A-4D5E-FBC1ACEB370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2444E9D-9081-F0E6-9312-3DDA7019E0F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CEE81C4-0B88-DBB0-1EC9-A878BE18AF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144BAA-6DA9-41D4-8889-B358DD12E476}" type="datetimeFigureOut">
              <a:rPr lang="en-US" smtClean="0"/>
              <a:t>2/17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32AC214-E06F-5443-3884-A5391B239B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5CC83F4-413A-BE2C-BF74-7DC26DE1ED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6926A0-4598-48F0-AF2B-5C818EA327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51266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33FA4AD-5E10-88B9-5FD9-39DE0B57F7C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BD2BD07-0625-4417-293E-DB6989D23C3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63F0424-EA93-8089-5839-1C3BE66E4F8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483F5B3-73B2-4BF8-09C0-40CEE47235A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6F3FA36-053E-99DA-694A-97E3495560C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12BD065-AE5D-6673-CA20-E4264AC156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144BAA-6DA9-41D4-8889-B358DD12E476}" type="datetimeFigureOut">
              <a:rPr lang="en-US" smtClean="0"/>
              <a:t>2/17/2026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FFFDA31-7260-9821-0A03-31AD8E4003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8917AE9-6665-C8F3-8172-10808A4CD0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6926A0-4598-48F0-AF2B-5C818EA327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45975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E472DBF-E7FF-9DC6-8F6F-4444BA17E2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5E71468-9DC9-BEBC-4447-C7FF7F5105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144BAA-6DA9-41D4-8889-B358DD12E476}" type="datetimeFigureOut">
              <a:rPr lang="en-US" smtClean="0"/>
              <a:t>2/17/2026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3D2A8A9-3394-8E7B-9576-F188930FE1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B9BCE1B-EA86-3C6E-5C87-3F4A012004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6926A0-4598-48F0-AF2B-5C818EA327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07379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79CC21A-A324-CCBC-AC8B-6165171807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144BAA-6DA9-41D4-8889-B358DD12E476}" type="datetimeFigureOut">
              <a:rPr lang="en-US" smtClean="0"/>
              <a:t>2/17/2026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82A65E1-DDD6-7198-9C6C-7EBFC35AB8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DB7D72D-6E72-E213-2458-DADB8886A8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6926A0-4598-48F0-AF2B-5C818EA327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83629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A06314-57FB-A555-1EA8-E9825427FB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8E8CDF4-19DB-FB52-CF45-4C569B28371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2CCEA72-8137-6E9E-24F9-5FBC141AD58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390B661-CDF0-0FF9-4E62-E2EA1321FA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144BAA-6DA9-41D4-8889-B358DD12E476}" type="datetimeFigureOut">
              <a:rPr lang="en-US" smtClean="0"/>
              <a:t>2/17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38786BB-85AA-939B-AA69-9A4E49279E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A121A61-3118-1739-ED88-86E055E946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6926A0-4598-48F0-AF2B-5C818EA327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26237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2F2A24D-8CE0-A73D-C744-820B32347F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BC11014-1A5E-B92F-7650-A8A3187C322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CF38520-863C-6792-F857-3394589FBF2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E695F10-1023-E1BC-1C50-A622F793DF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144BAA-6DA9-41D4-8889-B358DD12E476}" type="datetimeFigureOut">
              <a:rPr lang="en-US" smtClean="0"/>
              <a:t>2/17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CA822C5-8A75-0D6E-EAD2-77A4C36DDF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0836090-5556-F892-3BC0-96444530FB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6926A0-4598-48F0-AF2B-5C818EA327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26410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CF62321-8722-916C-B60A-57CAA433671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69F725E-A032-8734-D43F-F72414BE67F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B801ADA-8303-C0F2-FDD9-2455E20814C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5144BAA-6DA9-41D4-8889-B358DD12E476}" type="datetimeFigureOut">
              <a:rPr lang="en-US" smtClean="0"/>
              <a:t>2/17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1BA1437-395F-7350-B47A-FE18430AE80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5E125DD-1B58-70F4-846D-43049115656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D6926A0-4598-48F0-AF2B-5C818EA327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8955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>
            <a:extLst>
              <a:ext uri="{FF2B5EF4-FFF2-40B4-BE49-F238E27FC236}">
                <a16:creationId xmlns:a16="http://schemas.microsoft.com/office/drawing/2014/main" id="{4EBA39F8-16B1-EECF-1DE6-BA1869AFED6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39974" y="450215"/>
            <a:ext cx="7149181" cy="535853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2A400BC8-3D19-76BE-717B-D572B35DB294}"/>
              </a:ext>
            </a:extLst>
          </p:cNvPr>
          <p:cNvSpPr txBox="1"/>
          <p:nvPr/>
        </p:nvSpPr>
        <p:spPr>
          <a:xfrm>
            <a:off x="2124884" y="5808749"/>
            <a:ext cx="7579360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 S2. Physicochemical characterization of C-WFPM</a:t>
            </a:r>
            <a:r>
              <a:rPr lang="en-US" sz="11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0.1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and LS-WFPM</a:t>
            </a:r>
            <a:r>
              <a:rPr lang="en-US" sz="11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0.1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. A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D.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Organic carbon (OC) and elemental carbon (EC) percent composition in C-WFPM and LS-WFPM respectively.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B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E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Total elemental composition in C-WFPM and LS-WFPM. Mass concentration percentage of Polycyclic aromatic hydrocarbons (PAHs) in C-WFPM and LS-WFPM respectively in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C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F.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Figures reproduced from Laurent et al. [8]. Copyright [2024] American Chemical Society</a:t>
            </a:r>
          </a:p>
        </p:txBody>
      </p:sp>
    </p:spTree>
    <p:extLst>
      <p:ext uri="{BB962C8B-B14F-4D97-AF65-F5344CB8AC3E}">
        <p14:creationId xmlns:p14="http://schemas.microsoft.com/office/powerpoint/2010/main" val="12804358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6</TotalTime>
  <Words>83</Words>
  <Application>Microsoft Office PowerPoint</Application>
  <PresentationFormat>Widescreen</PresentationFormat>
  <Paragraphs>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Kuhelika Mali</dc:creator>
  <cp:lastModifiedBy>Kuhelika Mali</cp:lastModifiedBy>
  <cp:revision>7</cp:revision>
  <dcterms:created xsi:type="dcterms:W3CDTF">2025-11-02T02:31:05Z</dcterms:created>
  <dcterms:modified xsi:type="dcterms:W3CDTF">2026-02-17T17:45:11Z</dcterms:modified>
</cp:coreProperties>
</file>